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1" autoAdjust="0"/>
    <p:restoredTop sz="94660"/>
  </p:normalViewPr>
  <p:slideViewPr>
    <p:cSldViewPr snapToGrid="0">
      <p:cViewPr varScale="1">
        <p:scale>
          <a:sx n="76" d="100"/>
          <a:sy n="76" d="100"/>
        </p:scale>
        <p:origin x="67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21" Type="http://schemas.openxmlformats.org/officeDocument/2006/relationships/image" Target="../media/image21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20" Type="http://schemas.openxmlformats.org/officeDocument/2006/relationships/image" Target="../media/image20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23" Type="http://schemas.openxmlformats.org/officeDocument/2006/relationships/image" Target="../media/image23.emf"/><Relationship Id="rId10" Type="http://schemas.openxmlformats.org/officeDocument/2006/relationships/image" Target="../media/image10.emf"/><Relationship Id="rId19" Type="http://schemas.openxmlformats.org/officeDocument/2006/relationships/image" Target="../media/image19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Relationship Id="rId22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57B1C1-36C3-4FDC-AE0C-F41158AA654E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62F9FC-2C79-468E-A7F6-5ACD691932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7644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914650" y="842963"/>
            <a:ext cx="4043363" cy="22748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615420-7F4F-41AF-9F75-DDD5D046C7B3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910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7901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64412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97418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4710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54880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52964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9440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3454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2809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57173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16004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12DA4-CA0D-4D66-85F7-C78277954879}" type="datetimeFigureOut">
              <a:rPr lang="en-AU" smtClean="0"/>
              <a:t>9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2D1DF-6000-40AD-B316-FF856D50667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60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9" Type="http://schemas.openxmlformats.org/officeDocument/2006/relationships/oleObject" Target="../embeddings/oleObject17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emf"/><Relationship Id="rId34" Type="http://schemas.openxmlformats.org/officeDocument/2006/relationships/oleObject" Target="../embeddings/oleObject15.bin"/><Relationship Id="rId42" Type="http://schemas.openxmlformats.org/officeDocument/2006/relationships/image" Target="../media/image18.emf"/><Relationship Id="rId47" Type="http://schemas.openxmlformats.org/officeDocument/2006/relationships/image" Target="../media/image20.emf"/><Relationship Id="rId50" Type="http://schemas.openxmlformats.org/officeDocument/2006/relationships/oleObject" Target="../embeddings/oleObject22.bin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image" Target="../media/image11.emf"/><Relationship Id="rId33" Type="http://schemas.openxmlformats.org/officeDocument/2006/relationships/image" Target="../media/image25.png"/><Relationship Id="rId38" Type="http://schemas.openxmlformats.org/officeDocument/2006/relationships/image" Target="../media/image26.png"/><Relationship Id="rId46" Type="http://schemas.openxmlformats.org/officeDocument/2006/relationships/oleObject" Target="../embeddings/oleObject20.bin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image" Target="../media/image13.emf"/><Relationship Id="rId41" Type="http://schemas.openxmlformats.org/officeDocument/2006/relationships/oleObject" Target="../embeddings/oleObject18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24" Type="http://schemas.openxmlformats.org/officeDocument/2006/relationships/oleObject" Target="../embeddings/oleObject11.bin"/><Relationship Id="rId32" Type="http://schemas.openxmlformats.org/officeDocument/2006/relationships/image" Target="../media/image24.png"/><Relationship Id="rId37" Type="http://schemas.openxmlformats.org/officeDocument/2006/relationships/image" Target="../media/image16.emf"/><Relationship Id="rId40" Type="http://schemas.openxmlformats.org/officeDocument/2006/relationships/image" Target="../media/image17.emf"/><Relationship Id="rId45" Type="http://schemas.openxmlformats.org/officeDocument/2006/relationships/image" Target="../media/image19.emf"/><Relationship Id="rId53" Type="http://schemas.openxmlformats.org/officeDocument/2006/relationships/image" Target="../media/image23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23" Type="http://schemas.openxmlformats.org/officeDocument/2006/relationships/image" Target="../media/image10.emf"/><Relationship Id="rId28" Type="http://schemas.openxmlformats.org/officeDocument/2006/relationships/oleObject" Target="../embeddings/oleObject13.bin"/><Relationship Id="rId36" Type="http://schemas.openxmlformats.org/officeDocument/2006/relationships/oleObject" Target="../embeddings/oleObject16.bin"/><Relationship Id="rId49" Type="http://schemas.openxmlformats.org/officeDocument/2006/relationships/image" Target="../media/image21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31" Type="http://schemas.openxmlformats.org/officeDocument/2006/relationships/image" Target="../media/image14.emf"/><Relationship Id="rId44" Type="http://schemas.openxmlformats.org/officeDocument/2006/relationships/oleObject" Target="../embeddings/oleObject19.bin"/><Relationship Id="rId52" Type="http://schemas.openxmlformats.org/officeDocument/2006/relationships/oleObject" Target="../embeddings/oleObject23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15.emf"/><Relationship Id="rId43" Type="http://schemas.openxmlformats.org/officeDocument/2006/relationships/image" Target="../media/image27.png"/><Relationship Id="rId48" Type="http://schemas.openxmlformats.org/officeDocument/2006/relationships/oleObject" Target="../embeddings/oleObject21.bin"/><Relationship Id="rId8" Type="http://schemas.openxmlformats.org/officeDocument/2006/relationships/oleObject" Target="../embeddings/oleObject3.bin"/><Relationship Id="rId51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450172" y="496107"/>
          <a:ext cx="140266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0" name="Prism 6" r:id="rId4" imgW="2798975" imgH="2463814" progId="Prism6.Document">
                  <p:embed/>
                </p:oleObj>
              </mc:Choice>
              <mc:Fallback>
                <p:oleObj name="Prism 6" r:id="rId4" imgW="2798975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50172" y="496107"/>
                        <a:ext cx="140266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/>
          </p:nvPr>
        </p:nvGraphicFramePr>
        <p:xfrm>
          <a:off x="4704378" y="2701689"/>
          <a:ext cx="133901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1" name="Prism 6" r:id="rId6" imgW="2671127" imgH="2463814" progId="Prism6.Document">
                  <p:embed/>
                </p:oleObj>
              </mc:Choice>
              <mc:Fallback>
                <p:oleObj name="Prism 6" r:id="rId6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04378" y="2701689"/>
                        <a:ext cx="133901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490367" y="2734743"/>
          <a:ext cx="1414182" cy="12387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2" name="Prism 6" r:id="rId8" imgW="2822023" imgH="2472818" progId="Prism6.Document">
                  <p:embed/>
                </p:oleObj>
              </mc:Choice>
              <mc:Fallback>
                <p:oleObj name="Prism 6" r:id="rId8" imgW="2822023" imgH="247281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90367" y="2734743"/>
                        <a:ext cx="1414182" cy="12387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/>
          </p:nvPr>
        </p:nvGraphicFramePr>
        <p:xfrm>
          <a:off x="5823905" y="496107"/>
          <a:ext cx="133901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3" name="Prism 6" r:id="rId10" imgW="2671127" imgH="2463814" progId="Prism6.Document">
                  <p:embed/>
                </p:oleObj>
              </mc:Choice>
              <mc:Fallback>
                <p:oleObj name="Prism 6" r:id="rId10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823905" y="496107"/>
                        <a:ext cx="133901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/>
          </p:nvPr>
        </p:nvGraphicFramePr>
        <p:xfrm>
          <a:off x="4693439" y="496108"/>
          <a:ext cx="1337832" cy="12341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4" name="Prism 6" r:id="rId12" imgW="2671127" imgH="2463814" progId="Prism6.Document">
                  <p:embed/>
                </p:oleObj>
              </mc:Choice>
              <mc:Fallback>
                <p:oleObj name="Prism 6" r:id="rId12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693439" y="496108"/>
                        <a:ext cx="1337832" cy="12341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/>
          </p:nvPr>
        </p:nvGraphicFramePr>
        <p:xfrm>
          <a:off x="5822850" y="1641478"/>
          <a:ext cx="133901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5" name="Prism 6" r:id="rId14" imgW="2671127" imgH="2463814" progId="Prism6.Document">
                  <p:embed/>
                </p:oleObj>
              </mc:Choice>
              <mc:Fallback>
                <p:oleObj name="Prism 6" r:id="rId14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822850" y="1641478"/>
                        <a:ext cx="133901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/>
          </p:nvPr>
        </p:nvGraphicFramePr>
        <p:xfrm>
          <a:off x="3472385" y="1654504"/>
          <a:ext cx="1433307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6" name="Prism 6" r:id="rId16" imgW="2863079" imgH="2463814" progId="Prism6.Document">
                  <p:embed/>
                </p:oleObj>
              </mc:Choice>
              <mc:Fallback>
                <p:oleObj name="Prism 6" r:id="rId16" imgW="2863079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472385" y="1654504"/>
                        <a:ext cx="1433307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5797293" y="2701689"/>
          <a:ext cx="133901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7" name="Prism 6" r:id="rId18" imgW="2671127" imgH="2463814" progId="Prism6.Document">
                  <p:embed/>
                </p:oleObj>
              </mc:Choice>
              <mc:Fallback>
                <p:oleObj name="Prism 6" r:id="rId18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797293" y="2701689"/>
                        <a:ext cx="133901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6979386" y="519811"/>
          <a:ext cx="1102091" cy="1248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8" name="Prism 6" r:id="rId20" imgW="2168017" imgH="2457691" progId="Prism6.Document">
                  <p:embed/>
                </p:oleObj>
              </mc:Choice>
              <mc:Fallback>
                <p:oleObj name="Prism 6" r:id="rId20" imgW="2168017" imgH="245769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6979386" y="519811"/>
                        <a:ext cx="1102091" cy="1248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6924348" y="2709403"/>
          <a:ext cx="1321330" cy="12199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9" name="Prism 6" r:id="rId22" imgW="2671127" imgH="2463814" progId="Prism6.Document">
                  <p:embed/>
                </p:oleObj>
              </mc:Choice>
              <mc:Fallback>
                <p:oleObj name="Prism 6" r:id="rId22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6924348" y="2709403"/>
                        <a:ext cx="1321330" cy="12199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7299577"/>
              </p:ext>
            </p:extLst>
          </p:nvPr>
        </p:nvGraphicFramePr>
        <p:xfrm>
          <a:off x="7113881" y="4294112"/>
          <a:ext cx="1499676" cy="13064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0" name="Prism 6" r:id="rId24" imgW="2826705" imgH="2463814" progId="Prism6.Document">
                  <p:embed/>
                </p:oleObj>
              </mc:Choice>
              <mc:Fallback>
                <p:oleObj name="Prism 6" r:id="rId24" imgW="2826705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7113881" y="4294112"/>
                        <a:ext cx="1499676" cy="13064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bjec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3366234"/>
              </p:ext>
            </p:extLst>
          </p:nvPr>
        </p:nvGraphicFramePr>
        <p:xfrm>
          <a:off x="5804974" y="4293132"/>
          <a:ext cx="1499676" cy="13074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1" name="Prism 6" r:id="rId26" imgW="2826705" imgH="2463814" progId="Prism6.Document">
                  <p:embed/>
                </p:oleObj>
              </mc:Choice>
              <mc:Fallback>
                <p:oleObj name="Prism 6" r:id="rId26" imgW="2826705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5804974" y="4293132"/>
                        <a:ext cx="1499676" cy="13074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Box 43"/>
          <p:cNvSpPr txBox="1"/>
          <p:nvPr/>
        </p:nvSpPr>
        <p:spPr>
          <a:xfrm>
            <a:off x="6363387" y="5483221"/>
            <a:ext cx="731290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780" b="1" dirty="0" err="1"/>
              <a:t>TAA</a:t>
            </a:r>
            <a:r>
              <a:rPr lang="sv-SE" sz="780" b="1" dirty="0"/>
              <a:t> (mg/kg) </a:t>
            </a: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4705437" y="1636855"/>
          <a:ext cx="1337832" cy="12341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2" name="Prism 6" r:id="rId28" imgW="2671127" imgH="2463814" progId="Prism6.Document">
                  <p:embed/>
                </p:oleObj>
              </mc:Choice>
              <mc:Fallback>
                <p:oleObj name="Prism 6" r:id="rId28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4705437" y="1636855"/>
                        <a:ext cx="1337832" cy="12341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/>
          </p:nvPr>
        </p:nvGraphicFramePr>
        <p:xfrm>
          <a:off x="6912855" y="1620178"/>
          <a:ext cx="1339010" cy="12341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3" name="Prism 6" r:id="rId30" imgW="2671127" imgH="2463814" progId="Prism6.Document">
                  <p:embed/>
                </p:oleObj>
              </mc:Choice>
              <mc:Fallback>
                <p:oleObj name="Prism 6" r:id="rId30" imgW="2671127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6912855" y="1620178"/>
                        <a:ext cx="1339010" cy="12341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4007544" y="3888406"/>
            <a:ext cx="755335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TAA</a:t>
            </a:r>
            <a:r>
              <a:rPr lang="sv-SE" sz="817" b="1" dirty="0"/>
              <a:t> (mg/kg)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140623" y="3874478"/>
            <a:ext cx="755335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TAA</a:t>
            </a:r>
            <a:r>
              <a:rPr lang="sv-SE" sz="817" b="1" dirty="0"/>
              <a:t> (mg/kg)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225903" y="3882297"/>
            <a:ext cx="755335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TAA</a:t>
            </a:r>
            <a:r>
              <a:rPr lang="sv-SE" sz="817" b="1" dirty="0"/>
              <a:t> (mg/kg)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284414" y="3891727"/>
            <a:ext cx="755335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TAA</a:t>
            </a:r>
            <a:r>
              <a:rPr lang="sv-SE" sz="817" b="1" dirty="0"/>
              <a:t> (mg/kg) 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2100971" y="3246894"/>
            <a:ext cx="1144966" cy="212126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1735223" y="2983291"/>
            <a:ext cx="380232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/>
              <a:t>PRC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644767" y="3252927"/>
            <a:ext cx="559769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Vinculin</a:t>
            </a:r>
            <a:r>
              <a:rPr lang="sv-SE" sz="817" b="1" dirty="0"/>
              <a:t> </a:t>
            </a: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100971" y="2997960"/>
            <a:ext cx="1172519" cy="246274"/>
          </a:xfrm>
          <a:prstGeom prst="rect">
            <a:avLst/>
          </a:prstGeom>
        </p:spPr>
      </p:pic>
      <p:graphicFrame>
        <p:nvGraphicFramePr>
          <p:cNvPr id="38" name="Object 37"/>
          <p:cNvGraphicFramePr>
            <a:graphicFrameLocks noChangeAspect="1"/>
          </p:cNvGraphicFramePr>
          <p:nvPr>
            <p:extLst/>
          </p:nvPr>
        </p:nvGraphicFramePr>
        <p:xfrm>
          <a:off x="1940305" y="3614586"/>
          <a:ext cx="1359332" cy="12764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4" name="Prism 6" r:id="rId34" imgW="2863079" imgH="2689630" progId="Prism6.Document">
                  <p:embed/>
                </p:oleObj>
              </mc:Choice>
              <mc:Fallback>
                <p:oleObj name="Prism 6" r:id="rId34" imgW="2863079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1940305" y="3614586"/>
                        <a:ext cx="1359332" cy="12764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 noChangeAspect="1"/>
          </p:cNvGraphicFramePr>
          <p:nvPr>
            <p:extLst/>
          </p:nvPr>
        </p:nvGraphicFramePr>
        <p:xfrm>
          <a:off x="1949355" y="1355100"/>
          <a:ext cx="1312120" cy="1128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5" name="Prism 6" r:id="rId36" imgW="2863079" imgH="2463814" progId="Prism6.Document">
                  <p:embed/>
                </p:oleObj>
              </mc:Choice>
              <mc:Fallback>
                <p:oleObj name="Prism 6" r:id="rId36" imgW="2863079" imgH="246381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1949355" y="1355100"/>
                        <a:ext cx="1312120" cy="1128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2118377" y="728062"/>
            <a:ext cx="1245854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/>
              <a:t>  </a:t>
            </a:r>
            <a:r>
              <a:rPr lang="sv-SE" sz="817" b="1" dirty="0" err="1"/>
              <a:t>saline</a:t>
            </a:r>
            <a:r>
              <a:rPr lang="sv-SE" sz="817" b="1" dirty="0"/>
              <a:t>    50      100    200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2563859" y="891092"/>
            <a:ext cx="7113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598088" y="546725"/>
            <a:ext cx="764953" cy="2294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91" dirty="0" err="1"/>
              <a:t>TAA</a:t>
            </a:r>
            <a:r>
              <a:rPr lang="sv-SE" sz="891" dirty="0"/>
              <a:t> (mg/kg)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2220464" y="930998"/>
            <a:ext cx="1138630" cy="164566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1738189" y="900577"/>
            <a:ext cx="527709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/>
              <a:t>Cyp2E1 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74390" y="1100424"/>
            <a:ext cx="559769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 err="1"/>
              <a:t>Vinculin</a:t>
            </a:r>
            <a:r>
              <a:rPr lang="sv-SE" sz="817" b="1" dirty="0"/>
              <a:t> </a:t>
            </a:r>
          </a:p>
        </p:txBody>
      </p:sp>
      <p:graphicFrame>
        <p:nvGraphicFramePr>
          <p:cNvPr id="51" name="Object 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8216324"/>
              </p:ext>
            </p:extLst>
          </p:nvPr>
        </p:nvGraphicFramePr>
        <p:xfrm>
          <a:off x="3381052" y="4379889"/>
          <a:ext cx="1475029" cy="132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6" name="Prism 6" r:id="rId39" imgW="2991287" imgH="2689630" progId="Prism6.Document">
                  <p:embed/>
                </p:oleObj>
              </mc:Choice>
              <mc:Fallback>
                <p:oleObj name="Prism 6" r:id="rId39" imgW="2991287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3381052" y="4379889"/>
                        <a:ext cx="1475029" cy="132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0163223"/>
              </p:ext>
            </p:extLst>
          </p:nvPr>
        </p:nvGraphicFramePr>
        <p:xfrm>
          <a:off x="4553785" y="4390254"/>
          <a:ext cx="1443932" cy="13060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7" name="Prism 6" r:id="rId41" imgW="2972920" imgH="2689630" progId="Prism6.Document">
                  <p:embed/>
                </p:oleObj>
              </mc:Choice>
              <mc:Fallback>
                <p:oleObj name="Prism 6" r:id="rId41" imgW="2972920" imgH="26896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4553785" y="4390254"/>
                        <a:ext cx="1443932" cy="13060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2034963" y="2743284"/>
            <a:ext cx="1245854" cy="2180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17" b="1" dirty="0"/>
              <a:t>  </a:t>
            </a:r>
            <a:r>
              <a:rPr lang="sv-SE" sz="817" b="1" dirty="0" err="1"/>
              <a:t>saline</a:t>
            </a:r>
            <a:r>
              <a:rPr lang="sv-SE" sz="817" b="1" dirty="0"/>
              <a:t>    50      100    200</a:t>
            </a:r>
          </a:p>
        </p:txBody>
      </p:sp>
      <p:cxnSp>
        <p:nvCxnSpPr>
          <p:cNvPr id="54" name="Straight Connector 53"/>
          <p:cNvCxnSpPr/>
          <p:nvPr/>
        </p:nvCxnSpPr>
        <p:spPr>
          <a:xfrm>
            <a:off x="2480444" y="2906314"/>
            <a:ext cx="71131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2514673" y="2561948"/>
            <a:ext cx="764953" cy="2294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91" dirty="0" err="1"/>
              <a:t>TAA</a:t>
            </a:r>
            <a:r>
              <a:rPr lang="sv-SE" sz="891" dirty="0"/>
              <a:t> (mg/kg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2210371" y="1115575"/>
            <a:ext cx="1102150" cy="186475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7659129" y="5481761"/>
            <a:ext cx="731290" cy="2123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780" b="1" dirty="0" err="1"/>
              <a:t>TAA</a:t>
            </a:r>
            <a:r>
              <a:rPr lang="sv-SE" sz="780" b="1" dirty="0"/>
              <a:t> (mg/kg)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633713" y="2601068"/>
            <a:ext cx="312906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B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619774" y="466987"/>
            <a:ext cx="322524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A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312444" y="470206"/>
            <a:ext cx="304892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C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369838" y="4150358"/>
            <a:ext cx="328936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D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5691422" y="4267159"/>
            <a:ext cx="296876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E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59203" y="83567"/>
            <a:ext cx="2470356" cy="4122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079" dirty="0"/>
              <a:t>Supplemnetary Fig.1</a:t>
            </a:r>
          </a:p>
        </p:txBody>
      </p:sp>
      <p:graphicFrame>
        <p:nvGraphicFramePr>
          <p:cNvPr id="58" name="Objec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7471912"/>
              </p:ext>
            </p:extLst>
          </p:nvPr>
        </p:nvGraphicFramePr>
        <p:xfrm>
          <a:off x="8427568" y="571359"/>
          <a:ext cx="1413912" cy="10739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8" name="Prism 6" r:id="rId44" imgW="3759457" imgH="2855661" progId="Prism6.Document">
                  <p:embed/>
                </p:oleObj>
              </mc:Choice>
              <mc:Fallback>
                <p:oleObj name="Prism 6" r:id="rId44" imgW="3759457" imgH="285566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8427568" y="571359"/>
                        <a:ext cx="1413912" cy="10739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382653"/>
              </p:ext>
            </p:extLst>
          </p:nvPr>
        </p:nvGraphicFramePr>
        <p:xfrm>
          <a:off x="10244138" y="441325"/>
          <a:ext cx="1508125" cy="1674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9" name="Prism 6" r:id="rId46" imgW="2565967" imgH="2844857" progId="Prism6.Document">
                  <p:embed/>
                </p:oleObj>
              </mc:Choice>
              <mc:Fallback>
                <p:oleObj name="Prism 6" r:id="rId46" imgW="2565967" imgH="284485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7"/>
                      <a:stretch>
                        <a:fillRect/>
                      </a:stretch>
                    </p:blipFill>
                    <p:spPr>
                      <a:xfrm>
                        <a:off x="10244138" y="441325"/>
                        <a:ext cx="1508125" cy="1674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2417963"/>
              </p:ext>
            </p:extLst>
          </p:nvPr>
        </p:nvGraphicFramePr>
        <p:xfrm>
          <a:off x="10261600" y="2195513"/>
          <a:ext cx="1504950" cy="167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0" name="Prism 6" r:id="rId48" imgW="2565967" imgH="2855661" progId="Prism6.Document">
                  <p:embed/>
                </p:oleObj>
              </mc:Choice>
              <mc:Fallback>
                <p:oleObj name="Prism 6" r:id="rId48" imgW="2565967" imgH="285566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9"/>
                      <a:stretch>
                        <a:fillRect/>
                      </a:stretch>
                    </p:blipFill>
                    <p:spPr>
                      <a:xfrm>
                        <a:off x="10261600" y="2195513"/>
                        <a:ext cx="1504950" cy="167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0090967"/>
              </p:ext>
            </p:extLst>
          </p:nvPr>
        </p:nvGraphicFramePr>
        <p:xfrm>
          <a:off x="8613557" y="1675697"/>
          <a:ext cx="1227923" cy="10939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1" name="Prism 6" r:id="rId50" imgW="3265711" imgH="2912206" progId="Prism6.Document">
                  <p:embed/>
                </p:oleObj>
              </mc:Choice>
              <mc:Fallback>
                <p:oleObj name="Prism 6" r:id="rId50" imgW="3265711" imgH="291220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1"/>
                      <a:stretch>
                        <a:fillRect/>
                      </a:stretch>
                    </p:blipFill>
                    <p:spPr>
                      <a:xfrm>
                        <a:off x="8613557" y="1675697"/>
                        <a:ext cx="1227923" cy="10939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Rectangle 64"/>
          <p:cNvSpPr/>
          <p:nvPr/>
        </p:nvSpPr>
        <p:spPr>
          <a:xfrm>
            <a:off x="8846236" y="3816305"/>
            <a:ext cx="94395" cy="64934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66" name="Rectangle 65"/>
          <p:cNvSpPr/>
          <p:nvPr/>
        </p:nvSpPr>
        <p:spPr>
          <a:xfrm>
            <a:off x="8840348" y="3991680"/>
            <a:ext cx="94395" cy="649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67" name="Rectangle 66"/>
          <p:cNvSpPr/>
          <p:nvPr/>
        </p:nvSpPr>
        <p:spPr>
          <a:xfrm>
            <a:off x="8843178" y="4150358"/>
            <a:ext cx="94395" cy="64934"/>
          </a:xfrm>
          <a:prstGeom prst="rect">
            <a:avLst/>
          </a:prstGeom>
          <a:solidFill>
            <a:schemeClr val="tx1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68" name="TextBox 67"/>
          <p:cNvSpPr txBox="1"/>
          <p:nvPr/>
        </p:nvSpPr>
        <p:spPr>
          <a:xfrm>
            <a:off x="8916205" y="3758584"/>
            <a:ext cx="446921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aline</a:t>
            </a:r>
            <a:endParaRPr lang="sv-SE" sz="639" dirty="0"/>
          </a:p>
        </p:txBody>
      </p:sp>
      <p:sp>
        <p:nvSpPr>
          <p:cNvPr id="69" name="TextBox 68"/>
          <p:cNvSpPr txBox="1"/>
          <p:nvPr/>
        </p:nvSpPr>
        <p:spPr>
          <a:xfrm>
            <a:off x="8909632" y="3915040"/>
            <a:ext cx="1107748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cramble</a:t>
            </a:r>
            <a:r>
              <a:rPr lang="sv-SE" sz="639" dirty="0"/>
              <a:t>-Ad (VP/kg)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8899813" y="4082743"/>
            <a:ext cx="979209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hPRC</a:t>
            </a:r>
            <a:r>
              <a:rPr lang="sv-SE" sz="639" dirty="0"/>
              <a:t>-Ad (VP/kg)</a:t>
            </a:r>
          </a:p>
        </p:txBody>
      </p:sp>
      <p:graphicFrame>
        <p:nvGraphicFramePr>
          <p:cNvPr id="71" name="Object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8160942"/>
              </p:ext>
            </p:extLst>
          </p:nvPr>
        </p:nvGraphicFramePr>
        <p:xfrm>
          <a:off x="8652332" y="2718559"/>
          <a:ext cx="1197924" cy="10939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2" name="Prism 6" r:id="rId52" imgW="3192603" imgH="2912206" progId="Prism6.Document">
                  <p:embed/>
                </p:oleObj>
              </mc:Choice>
              <mc:Fallback>
                <p:oleObj name="Prism 6" r:id="rId52" imgW="3192603" imgH="291220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3"/>
                      <a:stretch>
                        <a:fillRect/>
                      </a:stretch>
                    </p:blipFill>
                    <p:spPr>
                      <a:xfrm>
                        <a:off x="8652332" y="2718559"/>
                        <a:ext cx="1197924" cy="10939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Box 74"/>
          <p:cNvSpPr txBox="1"/>
          <p:nvPr/>
        </p:nvSpPr>
        <p:spPr>
          <a:xfrm>
            <a:off x="8363470" y="333423"/>
            <a:ext cx="288862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F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0083136" y="312571"/>
            <a:ext cx="330540" cy="366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782" b="1" dirty="0"/>
              <a:t>G</a:t>
            </a: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2979AFCB-6BCA-4EEB-BFAD-D51153CBD796}"/>
              </a:ext>
            </a:extLst>
          </p:cNvPr>
          <p:cNvSpPr/>
          <p:nvPr/>
        </p:nvSpPr>
        <p:spPr>
          <a:xfrm>
            <a:off x="10723527" y="3826142"/>
            <a:ext cx="94395" cy="64934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2C34633F-C469-4DEC-B694-6E8C9CA34437}"/>
              </a:ext>
            </a:extLst>
          </p:cNvPr>
          <p:cNvSpPr/>
          <p:nvPr/>
        </p:nvSpPr>
        <p:spPr>
          <a:xfrm>
            <a:off x="10717639" y="4001517"/>
            <a:ext cx="94395" cy="64934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F08CC971-20FE-49CF-8CC9-822079ADF792}"/>
              </a:ext>
            </a:extLst>
          </p:cNvPr>
          <p:cNvSpPr/>
          <p:nvPr/>
        </p:nvSpPr>
        <p:spPr>
          <a:xfrm>
            <a:off x="10720469" y="4160195"/>
            <a:ext cx="94395" cy="64934"/>
          </a:xfrm>
          <a:prstGeom prst="rect">
            <a:avLst/>
          </a:prstGeom>
          <a:solidFill>
            <a:schemeClr val="tx1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sv-SE" sz="639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808244C-3C8D-45B2-9D89-44FA36D59CDC}"/>
              </a:ext>
            </a:extLst>
          </p:cNvPr>
          <p:cNvSpPr txBox="1"/>
          <p:nvPr/>
        </p:nvSpPr>
        <p:spPr>
          <a:xfrm>
            <a:off x="10793496" y="3768421"/>
            <a:ext cx="446921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aline</a:t>
            </a:r>
            <a:endParaRPr lang="sv-SE" sz="639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4C99C49-EEC3-47AA-9CDE-1C16B6864B22}"/>
              </a:ext>
            </a:extLst>
          </p:cNvPr>
          <p:cNvSpPr txBox="1"/>
          <p:nvPr/>
        </p:nvSpPr>
        <p:spPr>
          <a:xfrm>
            <a:off x="10786923" y="3924877"/>
            <a:ext cx="1107748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cramble</a:t>
            </a:r>
            <a:r>
              <a:rPr lang="sv-SE" sz="639" dirty="0"/>
              <a:t>-Ad (VP/kg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CE0126D-75FA-4E99-9C3C-E15D5E4F92AE}"/>
              </a:ext>
            </a:extLst>
          </p:cNvPr>
          <p:cNvSpPr txBox="1"/>
          <p:nvPr/>
        </p:nvSpPr>
        <p:spPr>
          <a:xfrm>
            <a:off x="10777104" y="4092580"/>
            <a:ext cx="979209" cy="190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639" dirty="0" err="1"/>
              <a:t>shPRC</a:t>
            </a:r>
            <a:r>
              <a:rPr lang="sv-SE" sz="639" dirty="0"/>
              <a:t>-Ad (VP/kg)</a:t>
            </a:r>
          </a:p>
        </p:txBody>
      </p:sp>
    </p:spTree>
    <p:extLst>
      <p:ext uri="{BB962C8B-B14F-4D97-AF65-F5344CB8AC3E}">
        <p14:creationId xmlns:p14="http://schemas.microsoft.com/office/powerpoint/2010/main" val="272696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5</TotalTime>
  <Words>100</Words>
  <Application>Microsoft Office PowerPoint</Application>
  <PresentationFormat>Widescreen</PresentationFormat>
  <Paragraphs>2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>CSIR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ler, Marcin (L&amp;W, Black Mountain)</dc:creator>
  <cp:lastModifiedBy>Buler, Marcin (L&amp;W, Black Mountain)</cp:lastModifiedBy>
  <cp:revision>12</cp:revision>
  <dcterms:created xsi:type="dcterms:W3CDTF">2019-06-18T05:23:11Z</dcterms:created>
  <dcterms:modified xsi:type="dcterms:W3CDTF">2019-10-09T00:19:04Z</dcterms:modified>
</cp:coreProperties>
</file>